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27.png" ContentType="image/png"/>
  <Override PartName="/ppt/media/image26.png" ContentType="image/png"/>
  <Override PartName="/ppt/media/image2.png" ContentType="image/png"/>
  <Override PartName="/ppt/media/image4.jpeg" ContentType="image/jpeg"/>
  <Override PartName="/ppt/media/image25.png" ContentType="image/png"/>
  <Override PartName="/ppt/media/image28.png" ContentType="image/png"/>
  <Override PartName="/ppt/media/image5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0.png" ContentType="image/png"/>
  <Override PartName="/ppt/media/image3.jpeg" ContentType="image/jpeg"/>
  <Override PartName="/ppt/media/image1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media/image2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  <p:sldId id="257" r:id="rId15"/>
    <p:sldId id="258" r:id="rId16"/>
    <p:sldId id="259" r:id="rId17"/>
    <p:sldId id="260" r:id="rId1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slide" Target="slides/slide2.xml"/><Relationship Id="rId16" Type="http://schemas.openxmlformats.org/officeDocument/2006/relationships/slide" Target="slides/slide3.xml"/><Relationship Id="rId17" Type="http://schemas.openxmlformats.org/officeDocument/2006/relationships/slide" Target="slides/slide4.xml"/><Relationship Id="rId18" Type="http://schemas.openxmlformats.org/officeDocument/2006/relationships/slide" Target="slides/slide5.xml"/><Relationship Id="rId1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79D6D-836D-4329-AB6B-B06A50ECC2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8BC69-6F0E-4F02-847C-C5A7AD8A1A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6310E84-8E7B-431B-9691-00F87D9E0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15EA4F4-303F-4025-A2A7-7AC4D2222A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8F25C35-3A03-459A-A733-A2E4365B0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F3B5462-C2B4-474D-8843-3F42E6BD85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6BAD0DE-A34A-4D24-A967-F64C08BCE5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574F1CD-F038-4E73-8BB8-222C9343A3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B6AA8EDB-6FF1-4DEA-95D2-BA67243182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52C5A14-2955-4185-96CD-19FCEA32A3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28F2893-3817-4CA1-A192-3ACFE9BDAE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55920DE-6F8F-4C82-8F5D-C3E4EAF27E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059F1-E881-4333-B5BF-A58207FCEB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848C1EE-D099-4D04-AD65-28E88EE90C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3F4916E-3EA6-49DE-8BDE-6A48BAE2B5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A1E3DB5-C5DF-4D20-A45C-75FAD65323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14ED22E-2950-439E-B497-4B60907CE3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D55E9BC-426B-4D23-901C-09D5FC9F0E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096FF45-5918-414F-8CB8-B6A8CF82E8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DF5D949-9463-44F9-9175-91FB69685E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0D32C94-DCE7-4CA8-8F75-6E3555DBC2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7F6865C-409B-4693-8D27-09F4271085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264C0C39-6E7E-4FC6-AB0A-7F41CA4E10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4FA53-9733-44BE-A880-AD5826AF24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2729CA4-4DC3-4FCB-AF27-5E969DFBBC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107395B-A20F-4199-B7F9-01CF9D4334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93E3F6F-5A7B-44CD-BE4B-E6D875F720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68DD3D9-85EC-4CA2-ADF3-C267F5ADBC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6729B4B-5EAC-4A0B-9B3A-696A7197D2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0364717-58AC-4A6B-8C15-616F2CDECA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5F9EFAE-E913-4296-B7C9-6EFE0595EA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D15B7ED-2386-4D79-839B-E2CFBE1BC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16857C2-CA64-4926-8900-306AA51AF3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2FC137B-7AB0-4985-932D-AFEC2B79E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D4342D0-241D-4E8A-9D91-85A9B242B8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DC181EE-AA71-4724-9291-4655B1B0D6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A671BC1-8E84-4336-A9C0-2A4E3FB32D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15E2FA3-3DF5-421A-B0F1-B9AE0C592C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65914F6-35EA-482A-9C23-251DB25526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0915C07-B1BC-4CBA-B646-99127B85DE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16CA3B6-E253-4DEB-BEED-73F33ACA44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23CA71E-4BEE-4341-908E-522E9950EA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A4E9F75-0FEE-4872-A289-B356F6623F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E068834-F00F-4A8D-82B4-D54B3189A7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EFCB295-63BE-429C-AC0A-E6868B423B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1849DA-2427-49FB-82C1-AAC04FA51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E1162B7-2B56-406B-996A-81877C565A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4E0A918-0E74-4A09-99A5-76BF8CA8C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5C746C3-AAA7-437E-859F-26E1213056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720FB82-93D7-4D8D-AD93-8AD6E8D00D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A1B5F2F-F105-4BD2-A582-FB63949A76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B619949-B3E1-40F5-9F80-B1D97F97D0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A4D5D4-6F58-42A7-A0B9-98ACEB697C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F29319B-833F-4F5A-B522-0DBA5ABE73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845504-B575-47DD-8600-D9A83306D2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4285135-374D-4206-B641-155DF2CAA8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8EB58-DBDC-45AF-BE00-269ACF0007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835A7C-F00D-4F96-94AD-766456C6B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425DDD-D164-41E5-8528-5E29E55E75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F70118-E538-4509-86FE-69F45BAE60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2CC793B-7A89-42DF-83F2-2D14911148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30A0951-3EF7-426E-9666-020165821B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4862090-DC3F-4EBF-B793-BC16A3A1FC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48D2212-5D8A-40D1-90A6-B97C92A482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E22ECC9-B432-4A07-BE34-66C91AB32A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FD36D30-0E4C-4719-B08B-F342033123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1663AC9-52E4-426E-89C6-68B3363524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C93F2-D9CC-4C56-A7B3-6C791463F1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B9970E2-9577-4A22-B56B-974819F3D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7D9BD01-E739-458A-9839-193821DA17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7FD581B-CA91-43A2-91A9-003872FD3E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7ED22F5-0C08-4275-BCD0-07F4842D8C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C076C58-4EC6-4178-A1E8-AB651E3E9E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043139A-2D4D-49A6-95FE-28B212BB0B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93244AB-C2FF-44C6-A88B-315D26CFD7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2391ADA-0979-46BA-A018-7368F6B5E9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465D664-ECE7-4DC9-B9DF-1DF143E861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77F7F68-72C6-4768-A64D-DBE4DC02F7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DD9BC-1822-4CDD-931A-A8CCF72B1A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DFCBA92-835B-46E8-9C74-6DCF00AC9C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5831F4B-9EE3-4088-92DD-49BE507479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925FDA0-3EA4-4B16-B935-971684779B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1906606-0467-4194-96C6-F42091FDA8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3BCF12C-7CD9-4F91-AC1B-59F59466B7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39750EC-4FE0-467F-A950-53999803F2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AE2499B-C6E8-4C61-9070-ECF720A554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678248A-0C31-4C14-A4D1-14F923B31B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A9D37A4-F3AC-42BD-BE93-FB84FB42CC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EB8EAED-C84B-447B-BB1B-5E3D560D3A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5B009-C614-4156-AAFA-D2331AA4C7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C7A7764-7CA7-40DD-8967-C7EA6ADA11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B36606C-5924-4CB4-B943-CE20BE67CA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7CE937E-6026-40AD-931C-4087E79A47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E6818B7-11F1-4F4D-9CB9-B628DB7933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6B2025A-7E26-4B0D-ACA1-54DD06A008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320206B-05F6-4AEF-86DB-4F023499E1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D5DFDAD-E307-4655-89AA-517912935F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B9B1BBD-F975-45D7-86C5-6CA91DAA0E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CB06F5B-0395-4A6D-AB1D-6150948D9F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2476E0B-85EF-49A9-B746-3254134DA8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3F7D4-0F9B-4628-A1B5-4C0402EDF8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2FD498D-1C90-4C67-B86A-EDEB6BA259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F3C35D8-89C5-4F82-8AE7-C4A7E57445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908C643-CBB6-4FDF-80D6-61D934979A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5598E40-AEB1-4CA7-9601-07D6DBFBFB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57B0A34-B406-4FF9-AD1B-6F27487613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8482FE1-42D8-44BD-9E84-B10967A019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FC00CF4-9F70-437D-9674-DBB1497639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44F5D47-0C22-4699-B0B6-A85C71E9E9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BABE2C9-3C81-48A4-ABB0-5684CC2F6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7841980-E368-420B-943C-A18AC33250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3B355-09DE-4D45-B2DE-2DA08BF36A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5999362-75F6-45D8-B345-F4B91375BC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D0E000C-19AA-40BF-BE6C-B93C17BDD6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8CCEEE9-3662-442D-A2D1-A1F41F2F75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5CDFFDF-7191-433B-BF56-ED9F287DDA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A41F625-745C-437B-90B8-65425F5B3C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944436B-5355-4CB0-9D3E-F8F511E036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6FF7A8D-8424-40AF-B562-61807A1972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DC91BF9-7B1A-4651-B7CB-B6BD2841CF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F9CA94B-EAA5-4EFA-B3C0-F0D078A730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B220CC6-AB82-4DAF-8484-4A6FA7113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5D691-F4E5-4249-88B4-614F653BAA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5E76B46-D2F9-4718-9C81-96F5AB24F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8F7EC52-3CF4-4DE3-973D-797E4D92B9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8134CC5-77F5-41EF-AFBF-0C9CD9C8A8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EB5E7D2-221E-454C-9CC7-0722740D5A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50437F7-903A-4D65-94F9-D3B0C92A92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2C62A15-71B7-44B4-BD24-34EB25A088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8528FCF-F9C3-49DC-8920-E4CF48686B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BD8EAC8-877C-4037-B811-4B81629824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29704AC-B0CE-4FD1-A7CA-C5530F53D9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ABD1815-17B3-4C39-A949-1F2FDEE74F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A0011-1520-4F4A-AB0A-17542A7FB1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64C0301-2A78-4B24-AF61-E34158A2C4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6434566-B3B5-4EEE-B467-144ADF2379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9CA1549-EDE9-436D-B871-F2685DE3BD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608F0C5-20FA-44C9-8194-1513179D80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A9CC0F7-F6E7-45F2-907C-CA67F1C5EA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912095E-B22D-4C12-9EE6-3D5E7E1C7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C97AFA7-CD7F-47F4-8F4A-982C9274C6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EB08A81-8B28-4019-927A-B3E53637B7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AD2F19F-97E3-4EAC-9B90-92BB522C35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62540AF-AC7D-4A4E-BDA1-65EB94D67B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B4AF8D-323F-4E79-A174-AF3FB3CAD956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D2836E-6DE3-4ED4-81F7-073AFBE4CA10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94834D-348F-47D6-AAAE-9B01ACF74E9D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447B24-3F8E-445B-89CB-4306FE2F1845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3D44CB-A523-40CC-9AF3-C8F626D3900D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79E6EC-5483-4B56-B2EF-E05A6E2CBDC6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0B17A6-7C30-40CB-B070-EE86CDE55533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90D35A-00FC-4ED3-A387-91A20FF2A335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462F3F-ADE4-4916-9D43-B27F34750681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C92ABA-2F31-44E4-A825-E688EDA0858B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EBB792-0300-4DAB-81C4-DA1DF700B199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2AD5E8-FA82-48CF-B9FC-46420B735789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9" Type="http://schemas.openxmlformats.org/officeDocument/2006/relationships/image" Target="../media/image13.png"/><Relationship Id="rId10" Type="http://schemas.openxmlformats.org/officeDocument/2006/relationships/image" Target="../media/image14.png"/><Relationship Id="rId11" Type="http://schemas.openxmlformats.org/officeDocument/2006/relationships/image" Target="../media/image15.png"/><Relationship Id="rId12" Type="http://schemas.openxmlformats.org/officeDocument/2006/relationships/image" Target="../media/image16.png"/><Relationship Id="rId13" Type="http://schemas.openxmlformats.org/officeDocument/2006/relationships/image" Target="../media/image17.png"/><Relationship Id="rId14" Type="http://schemas.openxmlformats.org/officeDocument/2006/relationships/image" Target="../media/image18.png"/><Relationship Id="rId15" Type="http://schemas.openxmlformats.org/officeDocument/2006/relationships/image" Target="../media/image19.png"/><Relationship Id="rId16" Type="http://schemas.openxmlformats.org/officeDocument/2006/relationships/image" Target="../media/image20.png"/><Relationship Id="rId17" Type="http://schemas.openxmlformats.org/officeDocument/2006/relationships/image" Target="../media/image21.png"/><Relationship Id="rId18" Type="http://schemas.openxmlformats.org/officeDocument/2006/relationships/image" Target="../media/image22.png"/><Relationship Id="rId19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image" Target="../media/image27.png"/><Relationship Id="rId6" Type="http://schemas.openxmlformats.org/officeDocument/2006/relationships/image" Target="../media/image28.png"/><Relationship Id="rId7" Type="http://schemas.openxmlformats.org/officeDocument/2006/relationships/image" Target="../media/image29.png"/><Relationship Id="rId8" Type="http://schemas.openxmlformats.org/officeDocument/2006/relationships/image" Target="../media/image30.png"/><Relationship Id="rId9" Type="http://schemas.openxmlformats.org/officeDocument/2006/relationships/image" Target="../media/image31.png"/><Relationship Id="rId10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文本框 5"/>
          <p:cNvSpPr/>
          <p:nvPr/>
        </p:nvSpPr>
        <p:spPr>
          <a:xfrm>
            <a:off x="201600" y="122400"/>
            <a:ext cx="39909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1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矩形 2"/>
          <p:cNvSpPr/>
          <p:nvPr/>
        </p:nvSpPr>
        <p:spPr>
          <a:xfrm>
            <a:off x="920880" y="4344840"/>
            <a:ext cx="2886120" cy="200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differential expression in transcriptome sequencing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catter plot of co-expressed genes between Mock and PRRSV infected in 3D4/21 cells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O functional enrichment analysis of DEGs between Mock and PRRSV infected in 3D4/21 cells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4" name="组合 4"/>
          <p:cNvGrpSpPr/>
          <p:nvPr/>
        </p:nvGrpSpPr>
        <p:grpSpPr>
          <a:xfrm>
            <a:off x="4410000" y="44280"/>
            <a:ext cx="6656400" cy="6718320"/>
            <a:chOff x="4410000" y="44280"/>
            <a:chExt cx="6656400" cy="6718320"/>
          </a:xfrm>
        </p:grpSpPr>
        <p:pic>
          <p:nvPicPr>
            <p:cNvPr id="495" name="图片 5" descr=""/>
            <p:cNvPicPr/>
            <p:nvPr/>
          </p:nvPicPr>
          <p:blipFill>
            <a:blip r:embed="rId1"/>
            <a:stretch/>
          </p:blipFill>
          <p:spPr>
            <a:xfrm>
              <a:off x="4410000" y="90360"/>
              <a:ext cx="6656400" cy="334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6" name="图片 4" descr=""/>
            <p:cNvPicPr/>
            <p:nvPr/>
          </p:nvPicPr>
          <p:blipFill>
            <a:blip r:embed="rId2"/>
            <a:stretch/>
          </p:blipFill>
          <p:spPr>
            <a:xfrm>
              <a:off x="4583160" y="3436560"/>
              <a:ext cx="6483240" cy="3326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7" name="文本框 14"/>
            <p:cNvSpPr/>
            <p:nvPr/>
          </p:nvSpPr>
          <p:spPr>
            <a:xfrm>
              <a:off x="4410000" y="44280"/>
              <a:ext cx="382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文本框 4"/>
            <p:cNvSpPr/>
            <p:nvPr/>
          </p:nvSpPr>
          <p:spPr>
            <a:xfrm>
              <a:off x="4410000" y="3420720"/>
              <a:ext cx="382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文本框 5"/>
          <p:cNvSpPr/>
          <p:nvPr/>
        </p:nvSpPr>
        <p:spPr>
          <a:xfrm>
            <a:off x="368280" y="471600"/>
            <a:ext cx="39909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2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矩形 2"/>
          <p:cNvSpPr/>
          <p:nvPr/>
        </p:nvSpPr>
        <p:spPr>
          <a:xfrm>
            <a:off x="1467000" y="4651200"/>
            <a:ext cx="9042120" cy="164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lecular cloning, transmembrane region and secondary structure prediction of porcine B4GALT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olecular cloning of B4GALT5 from Sus scrofa. Lane M, 2K Plus II DNA ladder; Lane1, gel-purified RT-PCR product of the segment containing complete encoding sequence; Lane 2, negative control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ansmembrane region prediction was conducted using online software CBS Prediction Servers (http://www.cbs.dtu.dk/services/TMHMM-2.0/)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condary structure prediction was conducted using online software PHYRE 2 Protein Fold Recognition Server (http://www.sbg.bio.ic.ac.uk/phyre2/html/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1" name="图片 3" descr=""/>
          <p:cNvPicPr/>
          <p:nvPr/>
        </p:nvPicPr>
        <p:blipFill>
          <a:blip r:embed="rId1"/>
          <a:stretch/>
        </p:blipFill>
        <p:spPr>
          <a:xfrm>
            <a:off x="1273320" y="1195560"/>
            <a:ext cx="8716680" cy="328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文本框 5"/>
          <p:cNvSpPr/>
          <p:nvPr/>
        </p:nvSpPr>
        <p:spPr>
          <a:xfrm>
            <a:off x="368280" y="471600"/>
            <a:ext cx="423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3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矩形 3"/>
          <p:cNvSpPr/>
          <p:nvPr/>
        </p:nvSpPr>
        <p:spPr>
          <a:xfrm>
            <a:off x="998640" y="4830840"/>
            <a:ext cx="1054404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3. Potential domains and sequence comparison of pB4GALT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potential domains of pB4GALT5 were generated using the CD-search tool from National Center for Biotechnology Information (NCBI)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equence comparison of pB4GALT5 and homologs from other species. The pB4GALT5 cDNA encoded an ORF with 388 amino acid-long protein, GeneBank Accession No. KY565579.1. pB4GALT5 amino acid sequence was compared with those from Homo sapiens B4GALT5 (hB4GALT5:NM_004776.3), Bos taurus B4GALT5 (bB4GALT5:XM_015466213.1), Ovis aries (oB4GALT5:XM_012189329.2), Felis catus (fB4GALT5:XM_019826375.1), Gallus gallus (gB4GALT5: XM_015302326.1) and danio rerio B4GALT5 (dViperin: NM_001045332.1) respectivel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4" name="图片 4" descr=""/>
          <p:cNvPicPr/>
          <p:nvPr/>
        </p:nvPicPr>
        <p:blipFill>
          <a:blip r:embed="rId1"/>
          <a:stretch/>
        </p:blipFill>
        <p:spPr>
          <a:xfrm>
            <a:off x="641520" y="1212840"/>
            <a:ext cx="11021760" cy="343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文本框 5"/>
          <p:cNvSpPr/>
          <p:nvPr/>
        </p:nvSpPr>
        <p:spPr>
          <a:xfrm>
            <a:off x="368280" y="471600"/>
            <a:ext cx="423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4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6" name="组合 4"/>
          <p:cNvGrpSpPr/>
          <p:nvPr/>
        </p:nvGrpSpPr>
        <p:grpSpPr>
          <a:xfrm>
            <a:off x="496800" y="1359000"/>
            <a:ext cx="4738680" cy="4333680"/>
            <a:chOff x="496800" y="1359000"/>
            <a:chExt cx="4738680" cy="4333680"/>
          </a:xfrm>
        </p:grpSpPr>
        <p:grpSp>
          <p:nvGrpSpPr>
            <p:cNvPr id="507" name="组合 5"/>
            <p:cNvGrpSpPr/>
            <p:nvPr/>
          </p:nvGrpSpPr>
          <p:grpSpPr>
            <a:xfrm>
              <a:off x="856080" y="1377720"/>
              <a:ext cx="4379400" cy="4314960"/>
              <a:chOff x="856080" y="1377720"/>
              <a:chExt cx="4379400" cy="4314960"/>
            </a:xfrm>
          </p:grpSpPr>
          <p:grpSp>
            <p:nvGrpSpPr>
              <p:cNvPr id="508" name="组合 7"/>
              <p:cNvGrpSpPr/>
              <p:nvPr/>
            </p:nvGrpSpPr>
            <p:grpSpPr>
              <a:xfrm>
                <a:off x="856080" y="1377720"/>
                <a:ext cx="4379400" cy="1406880"/>
                <a:chOff x="856080" y="1377720"/>
                <a:chExt cx="4379400" cy="1406880"/>
              </a:xfrm>
            </p:grpSpPr>
            <p:pic>
              <p:nvPicPr>
                <p:cNvPr id="509" name="图片 22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362680" y="1377720"/>
                  <a:ext cx="1372320" cy="1406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0" name="图片 23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859560" y="1382760"/>
                  <a:ext cx="1375920" cy="14018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1" name="图片 24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856080" y="1382760"/>
                  <a:ext cx="1384920" cy="14018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2" name="文本框 22"/>
                <p:cNvSpPr/>
                <p:nvPr/>
              </p:nvSpPr>
              <p:spPr>
                <a:xfrm>
                  <a:off x="2358720" y="138384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f33c"/>
                      </a:solidFill>
                      <a:latin typeface="Times New Roman"/>
                      <a:ea typeface="Times New Roman"/>
                    </a:rPr>
                    <a:t>GP4-Myc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3" name="文本框 22"/>
                <p:cNvSpPr/>
                <p:nvPr/>
              </p:nvSpPr>
              <p:spPr>
                <a:xfrm>
                  <a:off x="3883320" y="139788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1b05d9"/>
                      </a:solidFill>
                      <a:latin typeface="Times New Roman"/>
                      <a:ea typeface="Times New Roman"/>
                    </a:rPr>
                    <a:t>DAPI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4" name="文本框 22"/>
                <p:cNvSpPr/>
                <p:nvPr/>
              </p:nvSpPr>
              <p:spPr>
                <a:xfrm>
                  <a:off x="856080" y="140148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Merg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15" name="组合 8"/>
              <p:cNvGrpSpPr/>
              <p:nvPr/>
            </p:nvGrpSpPr>
            <p:grpSpPr>
              <a:xfrm>
                <a:off x="856080" y="2814480"/>
                <a:ext cx="4379400" cy="1419840"/>
                <a:chOff x="856080" y="2814480"/>
                <a:chExt cx="4379400" cy="1419840"/>
              </a:xfrm>
            </p:grpSpPr>
            <p:pic>
              <p:nvPicPr>
                <p:cNvPr id="516" name="图片 16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856080" y="2824560"/>
                  <a:ext cx="1384920" cy="14018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7" name="图片 17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3862800" y="2832480"/>
                  <a:ext cx="1372680" cy="14018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18" name="图片 18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2358720" y="2841480"/>
                  <a:ext cx="1376280" cy="13928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9" name="文本框 22"/>
                <p:cNvSpPr/>
                <p:nvPr/>
              </p:nvSpPr>
              <p:spPr>
                <a:xfrm>
                  <a:off x="856080" y="281448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Merg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0" name="文本框 23"/>
                <p:cNvSpPr/>
                <p:nvPr/>
              </p:nvSpPr>
              <p:spPr>
                <a:xfrm>
                  <a:off x="2347200" y="2843640"/>
                  <a:ext cx="1255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0000"/>
                      </a:solidFill>
                      <a:latin typeface="Times New Roman"/>
                      <a:ea typeface="Times New Roman"/>
                    </a:rPr>
                    <a:t>Flag-B4GALT5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1" name="文本框 22"/>
                <p:cNvSpPr/>
                <p:nvPr/>
              </p:nvSpPr>
              <p:spPr>
                <a:xfrm>
                  <a:off x="3878640" y="283320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1b05d9"/>
                      </a:solidFill>
                      <a:latin typeface="Times New Roman"/>
                      <a:ea typeface="Times New Roman"/>
                    </a:rPr>
                    <a:t>DAPI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22" name="组合 9"/>
              <p:cNvGrpSpPr/>
              <p:nvPr/>
            </p:nvGrpSpPr>
            <p:grpSpPr>
              <a:xfrm>
                <a:off x="856080" y="4291200"/>
                <a:ext cx="4379400" cy="1401480"/>
                <a:chOff x="856080" y="4291200"/>
                <a:chExt cx="4379400" cy="1401480"/>
              </a:xfrm>
            </p:grpSpPr>
            <p:pic>
              <p:nvPicPr>
                <p:cNvPr id="523" name="图片 10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861120" y="4291200"/>
                  <a:ext cx="1384920" cy="1401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24" name="图片 11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2365200" y="4291200"/>
                  <a:ext cx="1374480" cy="1401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25" name="图片 12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3861360" y="4298760"/>
                  <a:ext cx="1374120" cy="13939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26" name="文本框 22"/>
                <p:cNvSpPr/>
                <p:nvPr/>
              </p:nvSpPr>
              <p:spPr>
                <a:xfrm>
                  <a:off x="3876120" y="430632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f33c"/>
                      </a:solidFill>
                      <a:latin typeface="Times New Roman"/>
                      <a:ea typeface="Times New Roman"/>
                    </a:rPr>
                    <a:t>GP4-Myc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7" name="文本框 23"/>
                <p:cNvSpPr/>
                <p:nvPr/>
              </p:nvSpPr>
              <p:spPr>
                <a:xfrm>
                  <a:off x="2342520" y="4306320"/>
                  <a:ext cx="12553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ff0000"/>
                      </a:solidFill>
                      <a:latin typeface="Times New Roman"/>
                      <a:ea typeface="Times New Roman"/>
                    </a:rPr>
                    <a:t>Flag-B4GALT5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8" name="文本框 22"/>
                <p:cNvSpPr/>
                <p:nvPr/>
              </p:nvSpPr>
              <p:spPr>
                <a:xfrm>
                  <a:off x="856080" y="4315680"/>
                  <a:ext cx="103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ffffff"/>
                      </a:solidFill>
                      <a:latin typeface="Times New Roman"/>
                      <a:ea typeface="Times New Roman"/>
                    </a:rPr>
                    <a:t>Merg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529" name="文本框 41"/>
            <p:cNvSpPr/>
            <p:nvPr/>
          </p:nvSpPr>
          <p:spPr>
            <a:xfrm>
              <a:off x="496800" y="1359000"/>
              <a:ext cx="307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30" name="组合 28"/>
          <p:cNvGrpSpPr/>
          <p:nvPr/>
        </p:nvGrpSpPr>
        <p:grpSpPr>
          <a:xfrm>
            <a:off x="5964120" y="1359000"/>
            <a:ext cx="4791240" cy="4333680"/>
            <a:chOff x="5964120" y="1359000"/>
            <a:chExt cx="4791240" cy="4333680"/>
          </a:xfrm>
        </p:grpSpPr>
        <p:grpSp>
          <p:nvGrpSpPr>
            <p:cNvPr id="531" name="组合 29"/>
            <p:cNvGrpSpPr/>
            <p:nvPr/>
          </p:nvGrpSpPr>
          <p:grpSpPr>
            <a:xfrm>
              <a:off x="6266880" y="1385640"/>
              <a:ext cx="4488480" cy="4307040"/>
              <a:chOff x="6266880" y="1385640"/>
              <a:chExt cx="4488480" cy="4307040"/>
            </a:xfrm>
          </p:grpSpPr>
          <p:grpSp>
            <p:nvGrpSpPr>
              <p:cNvPr id="532" name="组合 31"/>
              <p:cNvGrpSpPr/>
              <p:nvPr/>
            </p:nvGrpSpPr>
            <p:grpSpPr>
              <a:xfrm>
                <a:off x="6266880" y="1385640"/>
                <a:ext cx="4488480" cy="4307040"/>
                <a:chOff x="6266880" y="1385640"/>
                <a:chExt cx="4488480" cy="4307040"/>
              </a:xfrm>
            </p:grpSpPr>
            <p:grpSp>
              <p:nvGrpSpPr>
                <p:cNvPr id="533" name="组合 36"/>
                <p:cNvGrpSpPr/>
                <p:nvPr/>
              </p:nvGrpSpPr>
              <p:grpSpPr>
                <a:xfrm>
                  <a:off x="6266880" y="1385640"/>
                  <a:ext cx="4482360" cy="1389600"/>
                  <a:chOff x="6266880" y="1385640"/>
                  <a:chExt cx="4482360" cy="1389600"/>
                </a:xfrm>
              </p:grpSpPr>
              <p:pic>
                <p:nvPicPr>
                  <p:cNvPr id="534" name="图片 47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6284160" y="1387800"/>
                    <a:ext cx="1424160" cy="13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35" name="图片 48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7814520" y="1389240"/>
                    <a:ext cx="1416960" cy="138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36" name="图片 4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9338040" y="1385640"/>
                    <a:ext cx="1411200" cy="1388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37" name="文本框 22"/>
                  <p:cNvSpPr/>
                  <p:nvPr/>
                </p:nvSpPr>
                <p:spPr>
                  <a:xfrm>
                    <a:off x="7812000" y="1385640"/>
                    <a:ext cx="1063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f33c"/>
                        </a:solidFill>
                        <a:latin typeface="Times New Roman"/>
                        <a:ea typeface="Times New Roman"/>
                      </a:rPr>
                      <a:t>GP3-Myc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8" name="文本框 22"/>
                  <p:cNvSpPr/>
                  <p:nvPr/>
                </p:nvSpPr>
                <p:spPr>
                  <a:xfrm>
                    <a:off x="9379440" y="1399320"/>
                    <a:ext cx="1063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1b05d9"/>
                        </a:solidFill>
                        <a:latin typeface="Times New Roman"/>
                        <a:ea typeface="Times New Roman"/>
                      </a:rPr>
                      <a:t>DAPI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9" name="文本框 22"/>
                  <p:cNvSpPr/>
                  <p:nvPr/>
                </p:nvSpPr>
                <p:spPr>
                  <a:xfrm>
                    <a:off x="6266880" y="1402920"/>
                    <a:ext cx="1063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ffffff"/>
                        </a:solidFill>
                        <a:latin typeface="Times New Roman"/>
                        <a:ea typeface="Times New Roman"/>
                      </a:rPr>
                      <a:t>Merge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40" name="组合 37"/>
                <p:cNvGrpSpPr/>
                <p:nvPr/>
              </p:nvGrpSpPr>
              <p:grpSpPr>
                <a:xfrm>
                  <a:off x="6295680" y="2816280"/>
                  <a:ext cx="4459680" cy="1409760"/>
                  <a:chOff x="6295680" y="2816280"/>
                  <a:chExt cx="4459680" cy="1409760"/>
                </a:xfrm>
              </p:grpSpPr>
              <p:pic>
                <p:nvPicPr>
                  <p:cNvPr id="541" name="图片 41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9332280" y="2816280"/>
                    <a:ext cx="1423080" cy="139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42" name="图片 42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7809840" y="2820960"/>
                    <a:ext cx="1422000" cy="140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43" name="图片 43" descr=""/>
                  <p:cNvPicPr/>
                  <p:nvPr/>
                </p:nvPicPr>
                <p:blipFill>
                  <a:blip r:embed="rId15"/>
                  <a:stretch/>
                </p:blipFill>
                <p:spPr>
                  <a:xfrm>
                    <a:off x="6295680" y="2820960"/>
                    <a:ext cx="1429200" cy="140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44" name="文本框 22"/>
                  <p:cNvSpPr/>
                  <p:nvPr/>
                </p:nvSpPr>
                <p:spPr>
                  <a:xfrm>
                    <a:off x="6295680" y="2826000"/>
                    <a:ext cx="1063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ffffff"/>
                        </a:solidFill>
                        <a:latin typeface="Times New Roman"/>
                        <a:ea typeface="Times New Roman"/>
                      </a:rPr>
                      <a:t>Merge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5" name="文本框 23"/>
                  <p:cNvSpPr/>
                  <p:nvPr/>
                </p:nvSpPr>
                <p:spPr>
                  <a:xfrm>
                    <a:off x="7828920" y="2854800"/>
                    <a:ext cx="12906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ff0000"/>
                        </a:solidFill>
                        <a:latin typeface="Times New Roman"/>
                        <a:ea typeface="Times New Roman"/>
                      </a:rPr>
                      <a:t>Flag-B4GALT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6" name="文本框 22"/>
                  <p:cNvSpPr/>
                  <p:nvPr/>
                </p:nvSpPr>
                <p:spPr>
                  <a:xfrm>
                    <a:off x="9403200" y="2844360"/>
                    <a:ext cx="1063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1b05d9"/>
                        </a:solidFill>
                        <a:latin typeface="Times New Roman"/>
                        <a:ea typeface="Times New Roman"/>
                      </a:rPr>
                      <a:t>DAPI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47" name="组合 38"/>
                <p:cNvGrpSpPr/>
                <p:nvPr/>
              </p:nvGrpSpPr>
              <p:grpSpPr>
                <a:xfrm>
                  <a:off x="9327240" y="4282560"/>
                  <a:ext cx="1422000" cy="1410120"/>
                  <a:chOff x="9327240" y="4282560"/>
                  <a:chExt cx="1422000" cy="1410120"/>
                </a:xfrm>
              </p:grpSpPr>
              <p:pic>
                <p:nvPicPr>
                  <p:cNvPr id="548" name="图片 3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9327240" y="4282560"/>
                    <a:ext cx="1422000" cy="141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49" name="文本框 22"/>
                  <p:cNvSpPr/>
                  <p:nvPr/>
                </p:nvSpPr>
                <p:spPr>
                  <a:xfrm>
                    <a:off x="9403200" y="4294080"/>
                    <a:ext cx="106344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f33c"/>
                        </a:solidFill>
                        <a:latin typeface="Times New Roman"/>
                        <a:ea typeface="Times New Roman"/>
                      </a:rPr>
                      <a:t>GP3-Myc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pic>
            <p:nvPicPr>
              <p:cNvPr id="550" name="图片 32" descr=""/>
              <p:cNvPicPr/>
              <p:nvPr/>
            </p:nvPicPr>
            <p:blipFill>
              <a:blip r:embed="rId17"/>
              <a:stretch/>
            </p:blipFill>
            <p:spPr>
              <a:xfrm>
                <a:off x="7809840" y="4287960"/>
                <a:ext cx="1421640" cy="1404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1" name="文本框 23"/>
              <p:cNvSpPr/>
              <p:nvPr/>
            </p:nvSpPr>
            <p:spPr>
              <a:xfrm>
                <a:off x="7809840" y="4314600"/>
                <a:ext cx="1290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Flag-B4GALT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552" name="图片 34" descr=""/>
              <p:cNvPicPr/>
              <p:nvPr/>
            </p:nvPicPr>
            <p:blipFill>
              <a:blip r:embed="rId18"/>
              <a:stretch/>
            </p:blipFill>
            <p:spPr>
              <a:xfrm>
                <a:off x="6304680" y="4282560"/>
                <a:ext cx="1421640" cy="1405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3" name="文本框 22"/>
              <p:cNvSpPr/>
              <p:nvPr/>
            </p:nvSpPr>
            <p:spPr>
              <a:xfrm>
                <a:off x="6304680" y="4287960"/>
                <a:ext cx="1063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ffffff"/>
                    </a:solidFill>
                    <a:latin typeface="Times New Roman"/>
                    <a:ea typeface="Times New Roman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54" name="文本框 70"/>
            <p:cNvSpPr/>
            <p:nvPr/>
          </p:nvSpPr>
          <p:spPr>
            <a:xfrm>
              <a:off x="5964120" y="1359000"/>
              <a:ext cx="320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5" name="文本框 5"/>
          <p:cNvSpPr/>
          <p:nvPr/>
        </p:nvSpPr>
        <p:spPr>
          <a:xfrm>
            <a:off x="368280" y="471600"/>
            <a:ext cx="4230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1" lang="en-US" sz="3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4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矩形 3"/>
          <p:cNvSpPr/>
          <p:nvPr/>
        </p:nvSpPr>
        <p:spPr>
          <a:xfrm>
            <a:off x="5510160" y="3699000"/>
            <a:ext cx="6402600" cy="228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.4. Exploration of the interaction between other GP proteins of PRRSV (GP2a, 3, and 4) and pB4GALT5 by immunofluorescence. (A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la cells were co-transfected with GP4-Myc and Flag-B4GALT5. The cells at 36 h post-transfection were fixed and double-stained with a rabbit anti-Myc mAb and a mouse anti-Flag antibody, and followed by FITC-conjugated anti-rabbit IgG (green) and Cy5-conjugated anti-mouse IgG (red). Nuclei were stained with DAPI (blue)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B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la cells were co-transfected with GP3-Myc and Flag-B4GALT5. Same treatment as above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C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la cells were co-transfected with GP2a-Myc and Flag-B4GALT5. Same treatment as abov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7" name="组合 28"/>
          <p:cNvGrpSpPr/>
          <p:nvPr/>
        </p:nvGrpSpPr>
        <p:grpSpPr>
          <a:xfrm>
            <a:off x="563400" y="1601640"/>
            <a:ext cx="4626000" cy="4165920"/>
            <a:chOff x="563400" y="1601640"/>
            <a:chExt cx="4626000" cy="4165920"/>
          </a:xfrm>
        </p:grpSpPr>
        <p:grpSp>
          <p:nvGrpSpPr>
            <p:cNvPr id="558" name="组合 29"/>
            <p:cNvGrpSpPr/>
            <p:nvPr/>
          </p:nvGrpSpPr>
          <p:grpSpPr>
            <a:xfrm>
              <a:off x="563400" y="1601640"/>
              <a:ext cx="4626000" cy="2771640"/>
              <a:chOff x="563400" y="1601640"/>
              <a:chExt cx="4626000" cy="2771640"/>
            </a:xfrm>
          </p:grpSpPr>
          <p:grpSp>
            <p:nvGrpSpPr>
              <p:cNvPr id="559" name="组合 36"/>
              <p:cNvGrpSpPr/>
              <p:nvPr/>
            </p:nvGrpSpPr>
            <p:grpSpPr>
              <a:xfrm>
                <a:off x="935640" y="1625760"/>
                <a:ext cx="4253760" cy="2747520"/>
                <a:chOff x="935640" y="1625760"/>
                <a:chExt cx="4253760" cy="2747520"/>
              </a:xfrm>
            </p:grpSpPr>
            <p:grpSp>
              <p:nvGrpSpPr>
                <p:cNvPr id="560" name="组合 38"/>
                <p:cNvGrpSpPr/>
                <p:nvPr/>
              </p:nvGrpSpPr>
              <p:grpSpPr>
                <a:xfrm>
                  <a:off x="935640" y="1625760"/>
                  <a:ext cx="4253760" cy="1367280"/>
                  <a:chOff x="935640" y="1625760"/>
                  <a:chExt cx="4253760" cy="1367280"/>
                </a:xfrm>
              </p:grpSpPr>
              <p:pic>
                <p:nvPicPr>
                  <p:cNvPr id="561" name="图片 46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2391480" y="1654560"/>
                    <a:ext cx="1364040" cy="1338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62" name="图片 4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45160" y="1664280"/>
                    <a:ext cx="1344240" cy="1328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63" name="图片 48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935640" y="1664280"/>
                    <a:ext cx="1352160" cy="132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64" name="文本框 22"/>
                  <p:cNvSpPr/>
                  <p:nvPr/>
                </p:nvSpPr>
                <p:spPr>
                  <a:xfrm>
                    <a:off x="2407320" y="1625760"/>
                    <a:ext cx="1012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f33c"/>
                        </a:solidFill>
                        <a:latin typeface="Times New Roman"/>
                        <a:ea typeface="Times New Roman"/>
                      </a:rPr>
                      <a:t>GP2a-Myc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5" name="文本框 22"/>
                  <p:cNvSpPr/>
                  <p:nvPr/>
                </p:nvSpPr>
                <p:spPr>
                  <a:xfrm>
                    <a:off x="3900240" y="1638720"/>
                    <a:ext cx="1012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1b05d9"/>
                        </a:solidFill>
                        <a:latin typeface="Times New Roman"/>
                        <a:ea typeface="Times New Roman"/>
                      </a:rPr>
                      <a:t>DAPI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6" name="文本框 22"/>
                  <p:cNvSpPr/>
                  <p:nvPr/>
                </p:nvSpPr>
                <p:spPr>
                  <a:xfrm>
                    <a:off x="935640" y="1642320"/>
                    <a:ext cx="1012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ffffff"/>
                        </a:solidFill>
                        <a:latin typeface="Times New Roman"/>
                        <a:ea typeface="Times New Roman"/>
                      </a:rPr>
                      <a:t>Merge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grpSp>
              <p:nvGrpSpPr>
                <p:cNvPr id="567" name="组合 39"/>
                <p:cNvGrpSpPr/>
                <p:nvPr/>
              </p:nvGrpSpPr>
              <p:grpSpPr>
                <a:xfrm>
                  <a:off x="939600" y="3023640"/>
                  <a:ext cx="4242240" cy="1349640"/>
                  <a:chOff x="939600" y="3023640"/>
                  <a:chExt cx="4242240" cy="1349640"/>
                </a:xfrm>
              </p:grpSpPr>
              <p:pic>
                <p:nvPicPr>
                  <p:cNvPr id="568" name="图片 40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837600" y="3023640"/>
                    <a:ext cx="1344240" cy="134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69" name="图片 41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2381760" y="3032280"/>
                    <a:ext cx="1373760" cy="1341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70" name="图片 4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939600" y="3032280"/>
                    <a:ext cx="1356840" cy="1341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71" name="文本框 22"/>
                  <p:cNvSpPr/>
                  <p:nvPr/>
                </p:nvSpPr>
                <p:spPr>
                  <a:xfrm>
                    <a:off x="939600" y="3044880"/>
                    <a:ext cx="1012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ffffff"/>
                        </a:solidFill>
                        <a:latin typeface="Times New Roman"/>
                        <a:ea typeface="Times New Roman"/>
                      </a:rPr>
                      <a:t>Merge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2" name="文本框 23"/>
                  <p:cNvSpPr/>
                  <p:nvPr/>
                </p:nvSpPr>
                <p:spPr>
                  <a:xfrm>
                    <a:off x="2400120" y="3072240"/>
                    <a:ext cx="12294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ff0000"/>
                        </a:solidFill>
                        <a:latin typeface="Times New Roman"/>
                        <a:ea typeface="Times New Roman"/>
                      </a:rPr>
                      <a:t>Flag-B4GALT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3" name="文本框 22"/>
                  <p:cNvSpPr/>
                  <p:nvPr/>
                </p:nvSpPr>
                <p:spPr>
                  <a:xfrm>
                    <a:off x="3899880" y="3062520"/>
                    <a:ext cx="10126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1b05d9"/>
                        </a:solidFill>
                        <a:latin typeface="Times New Roman"/>
                        <a:ea typeface="Times New Roman"/>
                      </a:rPr>
                      <a:t>DAPI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574" name="文本框 69"/>
              <p:cNvSpPr/>
              <p:nvPr/>
            </p:nvSpPr>
            <p:spPr>
              <a:xfrm>
                <a:off x="563400" y="1601640"/>
                <a:ext cx="301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75" name="图片 30" descr=""/>
            <p:cNvPicPr/>
            <p:nvPr/>
          </p:nvPicPr>
          <p:blipFill>
            <a:blip r:embed="rId7"/>
            <a:stretch/>
          </p:blipFill>
          <p:spPr>
            <a:xfrm>
              <a:off x="2381760" y="4435200"/>
              <a:ext cx="1357200" cy="133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6" name="图片 31" descr=""/>
            <p:cNvPicPr/>
            <p:nvPr/>
          </p:nvPicPr>
          <p:blipFill>
            <a:blip r:embed="rId8"/>
            <a:stretch/>
          </p:blipFill>
          <p:spPr>
            <a:xfrm>
              <a:off x="3817440" y="4449600"/>
              <a:ext cx="1364040" cy="1317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7" name="图片 32" descr=""/>
            <p:cNvPicPr/>
            <p:nvPr/>
          </p:nvPicPr>
          <p:blipFill>
            <a:blip r:embed="rId9"/>
            <a:stretch/>
          </p:blipFill>
          <p:spPr>
            <a:xfrm>
              <a:off x="932400" y="4412880"/>
              <a:ext cx="1370880" cy="1354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8" name="文本框 22"/>
            <p:cNvSpPr/>
            <p:nvPr/>
          </p:nvSpPr>
          <p:spPr>
            <a:xfrm>
              <a:off x="3845160" y="4456440"/>
              <a:ext cx="1012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f33c"/>
                  </a:solidFill>
                  <a:latin typeface="Times New Roman"/>
                  <a:ea typeface="Times New Roman"/>
                </a:rPr>
                <a:t>GP2a-Myc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文本框 23"/>
            <p:cNvSpPr/>
            <p:nvPr/>
          </p:nvSpPr>
          <p:spPr>
            <a:xfrm>
              <a:off x="2381760" y="4456440"/>
              <a:ext cx="1229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Flag-B4GALT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文本框 22"/>
            <p:cNvSpPr/>
            <p:nvPr/>
          </p:nvSpPr>
          <p:spPr>
            <a:xfrm>
              <a:off x="925920" y="4465080"/>
              <a:ext cx="1012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ff"/>
                  </a:solidFill>
                  <a:latin typeface="Times New Roman"/>
                  <a:ea typeface="Times New Roman"/>
                </a:rPr>
                <a:t>Merg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1-16T05:22:55Z</dcterms:created>
  <dc:creator>as us</dc:creator>
  <dc:description/>
  <dc:language>en-US</dc:language>
  <cp:lastModifiedBy>as us</cp:lastModifiedBy>
  <dcterms:modified xsi:type="dcterms:W3CDTF">2018-01-30T00:40:44Z</dcterms:modified>
  <cp:revision>6</cp:revision>
  <dc:subject/>
  <dc:title>PowerPoint 演示文稿</dc:title>
</cp:coreProperties>
</file>